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01" r:id="rId5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CC9900"/>
    <a:srgbClr val="FFCC00"/>
    <a:srgbClr val="FFFFFF"/>
    <a:srgbClr val="E8B7B7"/>
    <a:srgbClr val="A8CDD7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5161" autoAdjust="0"/>
  </p:normalViewPr>
  <p:slideViewPr>
    <p:cSldViewPr snapToGrid="0">
      <p:cViewPr varScale="1">
        <p:scale>
          <a:sx n="71" d="100"/>
          <a:sy n="71" d="100"/>
        </p:scale>
        <p:origin x="144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Weis" userId="6a51f4e6-0e93-4a18-834c-a49e1ed77407" providerId="ADAL" clId="{61204179-66FA-4961-99A5-39B32D506667}"/>
    <pc:docChg chg="delSld">
      <pc:chgData name="Sara Weis" userId="6a51f4e6-0e93-4a18-834c-a49e1ed77407" providerId="ADAL" clId="{61204179-66FA-4961-99A5-39B32D506667}" dt="2025-01-02T17:22:25.950" v="0" actId="2696"/>
      <pc:docMkLst>
        <pc:docMk/>
      </pc:docMkLst>
      <pc:sldChg chg="del">
        <pc:chgData name="Sara Weis" userId="6a51f4e6-0e93-4a18-834c-a49e1ed77407" providerId="ADAL" clId="{61204179-66FA-4961-99A5-39B32D506667}" dt="2025-01-02T17:22:25.950" v="0" actId="2696"/>
        <pc:sldMkLst>
          <pc:docMk/>
          <pc:sldMk cId="1103957350" sldId="302"/>
        </pc:sldMkLst>
      </pc:sldChg>
    </pc:docChg>
  </pc:docChgLst>
  <pc:docChgLst>
    <pc:chgData name="Sara Weis" userId="6a51f4e6-0e93-4a18-834c-a49e1ed77407" providerId="ADAL" clId="{9C5BD01B-F20E-41A2-9B79-9146F06FE46D}"/>
    <pc:docChg chg="custSel addSld delSld modSld">
      <pc:chgData name="Sara Weis" userId="6a51f4e6-0e93-4a18-834c-a49e1ed77407" providerId="ADAL" clId="{9C5BD01B-F20E-41A2-9B79-9146F06FE46D}" dt="2025-01-02T17:14:57.246" v="287" actId="20577"/>
      <pc:docMkLst>
        <pc:docMk/>
      </pc:docMkLst>
      <pc:sldChg chg="del">
        <pc:chgData name="Sara Weis" userId="6a51f4e6-0e93-4a18-834c-a49e1ed77407" providerId="ADAL" clId="{9C5BD01B-F20E-41A2-9B79-9146F06FE46D}" dt="2025-01-02T16:47:45.036" v="0" actId="2696"/>
        <pc:sldMkLst>
          <pc:docMk/>
          <pc:sldMk cId="2106248321" sldId="298"/>
        </pc:sldMkLst>
      </pc:sldChg>
      <pc:sldChg chg="addSp delSp modSp">
        <pc:chgData name="Sara Weis" userId="6a51f4e6-0e93-4a18-834c-a49e1ed77407" providerId="ADAL" clId="{9C5BD01B-F20E-41A2-9B79-9146F06FE46D}" dt="2025-01-02T17:14:57.246" v="287" actId="20577"/>
        <pc:sldMkLst>
          <pc:docMk/>
          <pc:sldMk cId="3697787146" sldId="301"/>
        </pc:sldMkLst>
        <pc:spChg chg="add mod">
          <ac:chgData name="Sara Weis" userId="6a51f4e6-0e93-4a18-834c-a49e1ed77407" providerId="ADAL" clId="{9C5BD01B-F20E-41A2-9B79-9146F06FE46D}" dt="2025-01-02T17:14:57.246" v="287" actId="20577"/>
          <ac:spMkLst>
            <pc:docMk/>
            <pc:sldMk cId="3697787146" sldId="301"/>
            <ac:spMk id="3" creationId="{5BA8A5DB-8B56-4375-B76B-1DD6A0A66638}"/>
          </ac:spMkLst>
        </pc:spChg>
        <pc:spChg chg="del">
          <ac:chgData name="Sara Weis" userId="6a51f4e6-0e93-4a18-834c-a49e1ed77407" providerId="ADAL" clId="{9C5BD01B-F20E-41A2-9B79-9146F06FE46D}" dt="2025-01-02T17:06:44.709" v="79" actId="478"/>
          <ac:spMkLst>
            <pc:docMk/>
            <pc:sldMk cId="3697787146" sldId="301"/>
            <ac:spMk id="5" creationId="{482EC21A-9C48-44AA-B0BF-C90E2EF40A89}"/>
          </ac:spMkLst>
        </pc:spChg>
        <pc:spChg chg="mod topLvl">
          <ac:chgData name="Sara Weis" userId="6a51f4e6-0e93-4a18-834c-a49e1ed77407" providerId="ADAL" clId="{9C5BD01B-F20E-41A2-9B79-9146F06FE46D}" dt="2025-01-02T17:12:04.497" v="250" actId="1076"/>
          <ac:spMkLst>
            <pc:docMk/>
            <pc:sldMk cId="3697787146" sldId="301"/>
            <ac:spMk id="40" creationId="{17A2B086-922E-4A22-B93C-C1506C9A891D}"/>
          </ac:spMkLst>
        </pc:spChg>
        <pc:spChg chg="mod topLvl">
          <ac:chgData name="Sara Weis" userId="6a51f4e6-0e93-4a18-834c-a49e1ed77407" providerId="ADAL" clId="{9C5BD01B-F20E-41A2-9B79-9146F06FE46D}" dt="2025-01-02T17:12:04.497" v="250" actId="1076"/>
          <ac:spMkLst>
            <pc:docMk/>
            <pc:sldMk cId="3697787146" sldId="301"/>
            <ac:spMk id="43" creationId="{1B63261F-5B34-4FAF-973A-117486502732}"/>
          </ac:spMkLst>
        </pc:spChg>
        <pc:spChg chg="mod">
          <ac:chgData name="Sara Weis" userId="6a51f4e6-0e93-4a18-834c-a49e1ed77407" providerId="ADAL" clId="{9C5BD01B-F20E-41A2-9B79-9146F06FE46D}" dt="2025-01-02T16:53:55.493" v="51" actId="121"/>
          <ac:spMkLst>
            <pc:docMk/>
            <pc:sldMk cId="3697787146" sldId="301"/>
            <ac:spMk id="56" creationId="{5A252B7C-F590-4C54-827F-9FBE6CA430D2}"/>
          </ac:spMkLst>
        </pc:spChg>
        <pc:spChg chg="mod">
          <ac:chgData name="Sara Weis" userId="6a51f4e6-0e93-4a18-834c-a49e1ed77407" providerId="ADAL" clId="{9C5BD01B-F20E-41A2-9B79-9146F06FE46D}" dt="2025-01-02T16:53:55.493" v="51" actId="121"/>
          <ac:spMkLst>
            <pc:docMk/>
            <pc:sldMk cId="3697787146" sldId="301"/>
            <ac:spMk id="57" creationId="{315EE578-6B8E-4185-AFF9-650CA9E307E7}"/>
          </ac:spMkLst>
        </pc:spChg>
        <pc:spChg chg="mod">
          <ac:chgData name="Sara Weis" userId="6a51f4e6-0e93-4a18-834c-a49e1ed77407" providerId="ADAL" clId="{9C5BD01B-F20E-41A2-9B79-9146F06FE46D}" dt="2025-01-02T16:53:55.493" v="51" actId="121"/>
          <ac:spMkLst>
            <pc:docMk/>
            <pc:sldMk cId="3697787146" sldId="301"/>
            <ac:spMk id="58" creationId="{22FA14AD-0F20-43B0-9C05-405C97092C1B}"/>
          </ac:spMkLst>
        </pc:spChg>
        <pc:spChg chg="del mod">
          <ac:chgData name="Sara Weis" userId="6a51f4e6-0e93-4a18-834c-a49e1ed77407" providerId="ADAL" clId="{9C5BD01B-F20E-41A2-9B79-9146F06FE46D}" dt="2025-01-02T17:09:54.861" v="85" actId="478"/>
          <ac:spMkLst>
            <pc:docMk/>
            <pc:sldMk cId="3697787146" sldId="301"/>
            <ac:spMk id="61" creationId="{CF3FD69B-8EB1-432C-96B4-539FD5CDF51C}"/>
          </ac:spMkLst>
        </pc:spChg>
        <pc:spChg chg="del mod">
          <ac:chgData name="Sara Weis" userId="6a51f4e6-0e93-4a18-834c-a49e1ed77407" providerId="ADAL" clId="{9C5BD01B-F20E-41A2-9B79-9146F06FE46D}" dt="2025-01-02T17:09:57.133" v="86" actId="478"/>
          <ac:spMkLst>
            <pc:docMk/>
            <pc:sldMk cId="3697787146" sldId="301"/>
            <ac:spMk id="96" creationId="{ED1F1807-7D76-42D5-A6C8-63B4164465BD}"/>
          </ac:spMkLst>
        </pc:spChg>
        <pc:grpChg chg="del mod">
          <ac:chgData name="Sara Weis" userId="6a51f4e6-0e93-4a18-834c-a49e1ed77407" providerId="ADAL" clId="{9C5BD01B-F20E-41A2-9B79-9146F06FE46D}" dt="2025-01-02T17:09:57.133" v="86" actId="478"/>
          <ac:grpSpMkLst>
            <pc:docMk/>
            <pc:sldMk cId="3697787146" sldId="301"/>
            <ac:grpSpMk id="2" creationId="{B3A65566-F496-49EC-9796-C4772607E706}"/>
          </ac:grpSpMkLst>
        </pc:grpChg>
        <pc:grpChg chg="add del mod">
          <ac:chgData name="Sara Weis" userId="6a51f4e6-0e93-4a18-834c-a49e1ed77407" providerId="ADAL" clId="{9C5BD01B-F20E-41A2-9B79-9146F06FE46D}" dt="2025-01-02T17:10:55.102" v="110" actId="165"/>
          <ac:grpSpMkLst>
            <pc:docMk/>
            <pc:sldMk cId="3697787146" sldId="301"/>
            <ac:grpSpMk id="4" creationId="{A4B708AA-C874-47A9-8402-1307FAF78E71}"/>
          </ac:grpSpMkLst>
        </pc:grpChg>
        <pc:grpChg chg="del mod">
          <ac:chgData name="Sara Weis" userId="6a51f4e6-0e93-4a18-834c-a49e1ed77407" providerId="ADAL" clId="{9C5BD01B-F20E-41A2-9B79-9146F06FE46D}" dt="2025-01-02T17:09:54.861" v="85" actId="478"/>
          <ac:grpSpMkLst>
            <pc:docMk/>
            <pc:sldMk cId="3697787146" sldId="301"/>
            <ac:grpSpMk id="7" creationId="{C4E3E8CA-09CF-4E30-B1BE-0C226D1D44BD}"/>
          </ac:grpSpMkLst>
        </pc:grpChg>
        <pc:grpChg chg="del mod">
          <ac:chgData name="Sara Weis" userId="6a51f4e6-0e93-4a18-834c-a49e1ed77407" providerId="ADAL" clId="{9C5BD01B-F20E-41A2-9B79-9146F06FE46D}" dt="2025-01-02T17:09:57.133" v="86" actId="478"/>
          <ac:grpSpMkLst>
            <pc:docMk/>
            <pc:sldMk cId="3697787146" sldId="301"/>
            <ac:grpSpMk id="63" creationId="{90812C86-76E7-434C-B059-E06486271081}"/>
          </ac:grpSpMkLst>
        </pc:grpChg>
        <pc:picChg chg="mod topLvl">
          <ac:chgData name="Sara Weis" userId="6a51f4e6-0e93-4a18-834c-a49e1ed77407" providerId="ADAL" clId="{9C5BD01B-F20E-41A2-9B79-9146F06FE46D}" dt="2025-01-02T17:12:04.497" v="250" actId="1076"/>
          <ac:picMkLst>
            <pc:docMk/>
            <pc:sldMk cId="3697787146" sldId="301"/>
            <ac:picMk id="42" creationId="{49B89DD3-5D40-463B-B3F1-9B32F3C36782}"/>
          </ac:picMkLst>
        </pc:picChg>
        <pc:picChg chg="mod topLvl">
          <ac:chgData name="Sara Weis" userId="6a51f4e6-0e93-4a18-834c-a49e1ed77407" providerId="ADAL" clId="{9C5BD01B-F20E-41A2-9B79-9146F06FE46D}" dt="2025-01-02T17:12:04.497" v="250" actId="1076"/>
          <ac:picMkLst>
            <pc:docMk/>
            <pc:sldMk cId="3697787146" sldId="301"/>
            <ac:picMk id="45" creationId="{E570AB55-64BA-4CA5-9FE3-C0D38EE395F6}"/>
          </ac:picMkLst>
        </pc:picChg>
      </pc:sldChg>
      <pc:sldChg chg="delSp modSp add">
        <pc:chgData name="Sara Weis" userId="6a51f4e6-0e93-4a18-834c-a49e1ed77407" providerId="ADAL" clId="{9C5BD01B-F20E-41A2-9B79-9146F06FE46D}" dt="2025-01-02T17:14:37.101" v="285" actId="403"/>
        <pc:sldMkLst>
          <pc:docMk/>
          <pc:sldMk cId="1103957350" sldId="302"/>
        </pc:sldMkLst>
        <pc:spChg chg="mod">
          <ac:chgData name="Sara Weis" userId="6a51f4e6-0e93-4a18-834c-a49e1ed77407" providerId="ADAL" clId="{9C5BD01B-F20E-41A2-9B79-9146F06FE46D}" dt="2025-01-02T17:14:37.101" v="285" actId="403"/>
          <ac:spMkLst>
            <pc:docMk/>
            <pc:sldMk cId="1103957350" sldId="302"/>
            <ac:spMk id="3" creationId="{5BA8A5DB-8B56-4375-B76B-1DD6A0A66638}"/>
          </ac:spMkLst>
        </pc:spChg>
        <pc:spChg chg="del">
          <ac:chgData name="Sara Weis" userId="6a51f4e6-0e93-4a18-834c-a49e1ed77407" providerId="ADAL" clId="{9C5BD01B-F20E-41A2-9B79-9146F06FE46D}" dt="2025-01-02T17:12:54.518" v="264" actId="478"/>
          <ac:spMkLst>
            <pc:docMk/>
            <pc:sldMk cId="1103957350" sldId="302"/>
            <ac:spMk id="40" creationId="{17A2B086-922E-4A22-B93C-C1506C9A891D}"/>
          </ac:spMkLst>
        </pc:spChg>
        <pc:spChg chg="del">
          <ac:chgData name="Sara Weis" userId="6a51f4e6-0e93-4a18-834c-a49e1ed77407" providerId="ADAL" clId="{9C5BD01B-F20E-41A2-9B79-9146F06FE46D}" dt="2025-01-02T17:12:57.167" v="265" actId="478"/>
          <ac:spMkLst>
            <pc:docMk/>
            <pc:sldMk cId="1103957350" sldId="302"/>
            <ac:spMk id="43" creationId="{1B63261F-5B34-4FAF-973A-117486502732}"/>
          </ac:spMkLst>
        </pc:spChg>
        <pc:spChg chg="mod">
          <ac:chgData name="Sara Weis" userId="6a51f4e6-0e93-4a18-834c-a49e1ed77407" providerId="ADAL" clId="{9C5BD01B-F20E-41A2-9B79-9146F06FE46D}" dt="2025-01-02T17:13:10.166" v="274" actId="404"/>
          <ac:spMkLst>
            <pc:docMk/>
            <pc:sldMk cId="1103957350" sldId="302"/>
            <ac:spMk id="56" creationId="{5A252B7C-F590-4C54-827F-9FBE6CA430D2}"/>
          </ac:spMkLst>
        </pc:spChg>
        <pc:spChg chg="mod">
          <ac:chgData name="Sara Weis" userId="6a51f4e6-0e93-4a18-834c-a49e1ed77407" providerId="ADAL" clId="{9C5BD01B-F20E-41A2-9B79-9146F06FE46D}" dt="2025-01-02T17:13:10.166" v="274" actId="404"/>
          <ac:spMkLst>
            <pc:docMk/>
            <pc:sldMk cId="1103957350" sldId="302"/>
            <ac:spMk id="57" creationId="{315EE578-6B8E-4185-AFF9-650CA9E307E7}"/>
          </ac:spMkLst>
        </pc:spChg>
        <pc:spChg chg="mod">
          <ac:chgData name="Sara Weis" userId="6a51f4e6-0e93-4a18-834c-a49e1ed77407" providerId="ADAL" clId="{9C5BD01B-F20E-41A2-9B79-9146F06FE46D}" dt="2025-01-02T17:13:10.166" v="274" actId="404"/>
          <ac:spMkLst>
            <pc:docMk/>
            <pc:sldMk cId="1103957350" sldId="302"/>
            <ac:spMk id="58" creationId="{22FA14AD-0F20-43B0-9C05-405C97092C1B}"/>
          </ac:spMkLst>
        </pc:spChg>
        <pc:spChg chg="mod">
          <ac:chgData name="Sara Weis" userId="6a51f4e6-0e93-4a18-834c-a49e1ed77407" providerId="ADAL" clId="{9C5BD01B-F20E-41A2-9B79-9146F06FE46D}" dt="2025-01-02T17:13:31.583" v="279" actId="552"/>
          <ac:spMkLst>
            <pc:docMk/>
            <pc:sldMk cId="1103957350" sldId="302"/>
            <ac:spMk id="61" creationId="{CF3FD69B-8EB1-432C-96B4-539FD5CDF51C}"/>
          </ac:spMkLst>
        </pc:spChg>
        <pc:spChg chg="mod">
          <ac:chgData name="Sara Weis" userId="6a51f4e6-0e93-4a18-834c-a49e1ed77407" providerId="ADAL" clId="{9C5BD01B-F20E-41A2-9B79-9146F06FE46D}" dt="2025-01-02T17:13:31.583" v="279" actId="552"/>
          <ac:spMkLst>
            <pc:docMk/>
            <pc:sldMk cId="1103957350" sldId="302"/>
            <ac:spMk id="96" creationId="{ED1F1807-7D76-42D5-A6C8-63B4164465BD}"/>
          </ac:spMkLst>
        </pc:spChg>
        <pc:grpChg chg="mod">
          <ac:chgData name="Sara Weis" userId="6a51f4e6-0e93-4a18-834c-a49e1ed77407" providerId="ADAL" clId="{9C5BD01B-F20E-41A2-9B79-9146F06FE46D}" dt="2025-01-02T17:13:22.434" v="277" actId="1076"/>
          <ac:grpSpMkLst>
            <pc:docMk/>
            <pc:sldMk cId="1103957350" sldId="302"/>
            <ac:grpSpMk id="2" creationId="{B3A65566-F496-49EC-9796-C4772607E706}"/>
          </ac:grpSpMkLst>
        </pc:grpChg>
        <pc:grpChg chg="mod">
          <ac:chgData name="Sara Weis" userId="6a51f4e6-0e93-4a18-834c-a49e1ed77407" providerId="ADAL" clId="{9C5BD01B-F20E-41A2-9B79-9146F06FE46D}" dt="2025-01-02T17:13:27.271" v="278" actId="1076"/>
          <ac:grpSpMkLst>
            <pc:docMk/>
            <pc:sldMk cId="1103957350" sldId="302"/>
            <ac:grpSpMk id="7" creationId="{C4E3E8CA-09CF-4E30-B1BE-0C226D1D44BD}"/>
          </ac:grpSpMkLst>
        </pc:grpChg>
        <pc:grpChg chg="mod">
          <ac:chgData name="Sara Weis" userId="6a51f4e6-0e93-4a18-834c-a49e1ed77407" providerId="ADAL" clId="{9C5BD01B-F20E-41A2-9B79-9146F06FE46D}" dt="2025-01-02T17:13:22.434" v="277" actId="1076"/>
          <ac:grpSpMkLst>
            <pc:docMk/>
            <pc:sldMk cId="1103957350" sldId="302"/>
            <ac:grpSpMk id="63" creationId="{90812C86-76E7-434C-B059-E06486271081}"/>
          </ac:grpSpMkLst>
        </pc:grpChg>
        <pc:picChg chg="del">
          <ac:chgData name="Sara Weis" userId="6a51f4e6-0e93-4a18-834c-a49e1ed77407" providerId="ADAL" clId="{9C5BD01B-F20E-41A2-9B79-9146F06FE46D}" dt="2025-01-02T17:12:54.518" v="264" actId="478"/>
          <ac:picMkLst>
            <pc:docMk/>
            <pc:sldMk cId="1103957350" sldId="302"/>
            <ac:picMk id="42" creationId="{49B89DD3-5D40-463B-B3F1-9B32F3C36782}"/>
          </ac:picMkLst>
        </pc:picChg>
        <pc:picChg chg="del">
          <ac:chgData name="Sara Weis" userId="6a51f4e6-0e93-4a18-834c-a49e1ed77407" providerId="ADAL" clId="{9C5BD01B-F20E-41A2-9B79-9146F06FE46D}" dt="2025-01-02T17:12:57.167" v="265" actId="478"/>
          <ac:picMkLst>
            <pc:docMk/>
            <pc:sldMk cId="1103957350" sldId="302"/>
            <ac:picMk id="45" creationId="{E570AB55-64BA-4CA5-9FE3-C0D38EE395F6}"/>
          </ac:picMkLst>
        </pc:picChg>
      </pc:sldChg>
      <pc:sldChg chg="del">
        <pc:chgData name="Sara Weis" userId="6a51f4e6-0e93-4a18-834c-a49e1ed77407" providerId="ADAL" clId="{9C5BD01B-F20E-41A2-9B79-9146F06FE46D}" dt="2025-01-02T16:47:45.042" v="1" actId="2696"/>
        <pc:sldMkLst>
          <pc:docMk/>
          <pc:sldMk cId="1407140874" sldId="309"/>
        </pc:sldMkLst>
      </pc:sldChg>
      <pc:sldChg chg="del">
        <pc:chgData name="Sara Weis" userId="6a51f4e6-0e93-4a18-834c-a49e1ed77407" providerId="ADAL" clId="{9C5BD01B-F20E-41A2-9B79-9146F06FE46D}" dt="2025-01-02T16:47:45.051" v="2" actId="2696"/>
        <pc:sldMkLst>
          <pc:docMk/>
          <pc:sldMk cId="2712744224" sldId="31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8556F641-4CF0-450A-AF50-26BA00F47CDE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06F44C2-743C-4165-B45D-193A312A7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2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50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769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329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291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570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90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731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15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6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0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21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04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17A2B086-922E-4A22-B93C-C1506C9A891D}"/>
              </a:ext>
            </a:extLst>
          </p:cNvPr>
          <p:cNvSpPr txBox="1"/>
          <p:nvPr/>
        </p:nvSpPr>
        <p:spPr>
          <a:xfrm>
            <a:off x="84052" y="1916683"/>
            <a:ext cx="314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49B89DD3-5D40-463B-B3F1-9B32F3C36782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307" y="2106938"/>
            <a:ext cx="6170447" cy="2137942"/>
          </a:xfrm>
          <a:prstGeom prst="rect">
            <a:avLst/>
          </a:prstGeom>
          <a:noFill/>
          <a:ln>
            <a:noFill/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1B63261F-5B34-4FAF-973A-117486502732}"/>
              </a:ext>
            </a:extLst>
          </p:cNvPr>
          <p:cNvSpPr txBox="1"/>
          <p:nvPr/>
        </p:nvSpPr>
        <p:spPr>
          <a:xfrm>
            <a:off x="84052" y="4639085"/>
            <a:ext cx="314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E570AB55-64BA-4CA5-9FE3-C0D38EE395F6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72" y="4606042"/>
            <a:ext cx="5276115" cy="2090972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BA8A5DB-8B56-4375-B76B-1DD6A0A66638}"/>
              </a:ext>
            </a:extLst>
          </p:cNvPr>
          <p:cNvSpPr/>
          <p:nvPr/>
        </p:nvSpPr>
        <p:spPr>
          <a:xfrm>
            <a:off x="84052" y="125476"/>
            <a:ext cx="6580989" cy="15716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:  Validation of KP4-luc orthotopic pancreatic cancer model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000" u="sng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 Effect of tumor cell number on tumor take: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 determine an injection number that would allow us to assess changes in tumor initiation at a relatively early timepoint, we performed a pilot study to compare orthotopic injections of 5, 1, or 0.2 million KP4-luc cells.  While no tumors were detected by bioluminescence imaging after 5 weeks, imaging at 10 weeks revealed tumors in 3/3 mice that received 5 or 1 million KP4-Luc cells but only 1/3 mice for the 0.2 million cell group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000" u="sng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:  Duration of siRNA-mediated knockdown of FN: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ting to assess the duration of siRNA-mediated knockdown of FN1 for CAFs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7787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543e7ec-7072-4b75-829f-0ed03e19ff1e">
      <Terms xmlns="http://schemas.microsoft.com/office/infopath/2007/PartnerControls"/>
    </lcf76f155ced4ddcb4097134ff3c332f>
    <TaxCatchAll xmlns="57a0c4cc-3c09-49e8-920e-d8be8823b2ff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F3B51C6BCD074793790340586B5297" ma:contentTypeVersion="18" ma:contentTypeDescription="Create a new document." ma:contentTypeScope="" ma:versionID="d8e7e0b6111b9d67775a07373b940835">
  <xsd:schema xmlns:xsd="http://www.w3.org/2001/XMLSchema" xmlns:xs="http://www.w3.org/2001/XMLSchema" xmlns:p="http://schemas.microsoft.com/office/2006/metadata/properties" xmlns:ns2="57a0c4cc-3c09-49e8-920e-d8be8823b2ff" xmlns:ns3="2543e7ec-7072-4b75-829f-0ed03e19ff1e" targetNamespace="http://schemas.microsoft.com/office/2006/metadata/properties" ma:root="true" ma:fieldsID="26eab72f2527c02910f532a8625ffb45" ns2:_="" ns3:_="">
    <xsd:import namespace="57a0c4cc-3c09-49e8-920e-d8be8823b2ff"/>
    <xsd:import namespace="2543e7ec-7072-4b75-829f-0ed03e19ff1e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Location" minOccurs="0"/>
                <xsd:element ref="ns3:lcf76f155ced4ddcb4097134ff3c332f" minOccurs="0"/>
                <xsd:element ref="ns2:TaxCatchAll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a0c4cc-3c09-49e8-920e-d8be8823b2f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bfe539f8-3b21-43ac-9575-bd53185d5a89}" ma:internalName="TaxCatchAll" ma:showField="CatchAllData" ma:web="57a0c4cc-3c09-49e8-920e-d8be8823b2f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43e7ec-7072-4b75-829f-0ed03e19ff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2ccd466c-82b6-42a3-8ba5-5c7db83406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28AF018-5240-4F2F-B0A7-10A84DD9D26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8778B21-93DC-4DE6-9C7D-29A88DF3DBC8}">
  <ds:schemaRefs>
    <ds:schemaRef ds:uri="http://schemas.microsoft.com/office/2006/metadata/properties"/>
    <ds:schemaRef ds:uri="http://purl.org/dc/terms/"/>
    <ds:schemaRef ds:uri="http://schemas.microsoft.com/office/2006/documentManagement/types"/>
    <ds:schemaRef ds:uri="http://purl.org/dc/dcmitype/"/>
    <ds:schemaRef ds:uri="57a0c4cc-3c09-49e8-920e-d8be8823b2ff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2543e7ec-7072-4b75-829f-0ed03e19ff1e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01E279D-CEC9-47C5-B8DD-CF8E61B016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7a0c4cc-3c09-49e8-920e-d8be8823b2ff"/>
    <ds:schemaRef ds:uri="2543e7ec-7072-4b75-829f-0ed03e19ff1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7</TotalTime>
  <Words>127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Chengsheng</dc:creator>
  <cp:lastModifiedBy>Weis, Sara</cp:lastModifiedBy>
  <cp:revision>20</cp:revision>
  <dcterms:created xsi:type="dcterms:W3CDTF">2024-03-19T17:07:22Z</dcterms:created>
  <dcterms:modified xsi:type="dcterms:W3CDTF">2025-01-02T17:22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F3B51C6BCD074793790340586B5297</vt:lpwstr>
  </property>
  <property fmtid="{D5CDD505-2E9C-101B-9397-08002B2CF9AE}" pid="3" name="MediaServiceImageTags">
    <vt:lpwstr/>
  </property>
</Properties>
</file>